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12192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5" autoAdjust="0"/>
    <p:restoredTop sz="94660"/>
  </p:normalViewPr>
  <p:slideViewPr>
    <p:cSldViewPr snapToGrid="0" showGuides="1">
      <p:cViewPr>
        <p:scale>
          <a:sx n="90" d="100"/>
          <a:sy n="90" d="100"/>
        </p:scale>
        <p:origin x="1699" y="-3336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18734-551A-497F-8C76-9474D866981D}" type="datetimeFigureOut">
              <a:rPr lang="fr-FR" smtClean="0"/>
              <a:t>23/01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5F153-53BF-40AB-960C-A64AD8FEA6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3974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18734-551A-497F-8C76-9474D866981D}" type="datetimeFigureOut">
              <a:rPr lang="fr-FR" smtClean="0"/>
              <a:t>23/01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5F153-53BF-40AB-960C-A64AD8FEA6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29140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18734-551A-497F-8C76-9474D866981D}" type="datetimeFigureOut">
              <a:rPr lang="fr-FR" smtClean="0"/>
              <a:t>23/01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5F153-53BF-40AB-960C-A64AD8FEA6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72411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18734-551A-497F-8C76-9474D866981D}" type="datetimeFigureOut">
              <a:rPr lang="fr-FR" smtClean="0"/>
              <a:t>23/01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5F153-53BF-40AB-960C-A64AD8FEA6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44519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18734-551A-497F-8C76-9474D866981D}" type="datetimeFigureOut">
              <a:rPr lang="fr-FR" smtClean="0"/>
              <a:t>23/01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5F153-53BF-40AB-960C-A64AD8FEA6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932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18734-551A-497F-8C76-9474D866981D}" type="datetimeFigureOut">
              <a:rPr lang="fr-FR" smtClean="0"/>
              <a:t>23/01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5F153-53BF-40AB-960C-A64AD8FEA6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4268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18734-551A-497F-8C76-9474D866981D}" type="datetimeFigureOut">
              <a:rPr lang="fr-FR" smtClean="0"/>
              <a:t>23/01/2018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5F153-53BF-40AB-960C-A64AD8FEA6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5054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18734-551A-497F-8C76-9474D866981D}" type="datetimeFigureOut">
              <a:rPr lang="fr-FR" smtClean="0"/>
              <a:t>23/01/2018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5F153-53BF-40AB-960C-A64AD8FEA6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6542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18734-551A-497F-8C76-9474D866981D}" type="datetimeFigureOut">
              <a:rPr lang="fr-FR" smtClean="0"/>
              <a:t>23/01/2018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5F153-53BF-40AB-960C-A64AD8FEA6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23033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18734-551A-497F-8C76-9474D866981D}" type="datetimeFigureOut">
              <a:rPr lang="fr-FR" smtClean="0"/>
              <a:t>23/01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5F153-53BF-40AB-960C-A64AD8FEA6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91394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18734-551A-497F-8C76-9474D866981D}" type="datetimeFigureOut">
              <a:rPr lang="fr-FR" smtClean="0"/>
              <a:t>23/01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5F153-53BF-40AB-960C-A64AD8FEA6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99953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618734-551A-497F-8C76-9474D866981D}" type="datetimeFigureOut">
              <a:rPr lang="fr-FR" smtClean="0"/>
              <a:t>23/01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B5F153-53BF-40AB-960C-A64AD8FEA6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1553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08"/>
          <a:stretch/>
        </p:blipFill>
        <p:spPr>
          <a:xfrm>
            <a:off x="193504" y="694267"/>
            <a:ext cx="3321392" cy="10947400"/>
          </a:xfrm>
          <a:prstGeom prst="rect">
            <a:avLst/>
          </a:prstGeom>
        </p:spPr>
      </p:pic>
      <p:cxnSp>
        <p:nvCxnSpPr>
          <p:cNvPr id="4" name="Connecteur droit 3"/>
          <p:cNvCxnSpPr/>
          <p:nvPr/>
        </p:nvCxnSpPr>
        <p:spPr>
          <a:xfrm>
            <a:off x="990600" y="762000"/>
            <a:ext cx="2884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1346200" y="762000"/>
            <a:ext cx="2884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Connecteur droit 5"/>
          <p:cNvCxnSpPr/>
          <p:nvPr/>
        </p:nvCxnSpPr>
        <p:spPr>
          <a:xfrm>
            <a:off x="1709057" y="762000"/>
            <a:ext cx="2884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Connecteur droit 6"/>
          <p:cNvCxnSpPr/>
          <p:nvPr/>
        </p:nvCxnSpPr>
        <p:spPr>
          <a:xfrm>
            <a:off x="2108207" y="758371"/>
            <a:ext cx="2884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necteur droit 7"/>
          <p:cNvCxnSpPr/>
          <p:nvPr/>
        </p:nvCxnSpPr>
        <p:spPr>
          <a:xfrm>
            <a:off x="2463807" y="758371"/>
            <a:ext cx="2884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Connecteur droit 8"/>
          <p:cNvCxnSpPr/>
          <p:nvPr/>
        </p:nvCxnSpPr>
        <p:spPr>
          <a:xfrm>
            <a:off x="2826664" y="758371"/>
            <a:ext cx="2884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9" name="Groupe 18"/>
          <p:cNvGrpSpPr/>
          <p:nvPr/>
        </p:nvGrpSpPr>
        <p:grpSpPr>
          <a:xfrm>
            <a:off x="966246" y="231101"/>
            <a:ext cx="2148889" cy="543198"/>
            <a:chOff x="966246" y="231101"/>
            <a:chExt cx="2148889" cy="543198"/>
          </a:xfrm>
        </p:grpSpPr>
        <p:sp>
          <p:nvSpPr>
            <p:cNvPr id="10" name="ZoneTexte 9"/>
            <p:cNvSpPr txBox="1"/>
            <p:nvPr/>
          </p:nvSpPr>
          <p:spPr>
            <a:xfrm>
              <a:off x="966246" y="528078"/>
              <a:ext cx="10182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E      LE      S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2051602" y="524246"/>
              <a:ext cx="10182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E      LE      S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Connecteur droit 12"/>
            <p:cNvCxnSpPr/>
            <p:nvPr/>
          </p:nvCxnSpPr>
          <p:spPr>
            <a:xfrm>
              <a:off x="990600" y="524233"/>
              <a:ext cx="997862" cy="1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necteur droit 13"/>
            <p:cNvCxnSpPr/>
            <p:nvPr/>
          </p:nvCxnSpPr>
          <p:spPr>
            <a:xfrm>
              <a:off x="2111842" y="524233"/>
              <a:ext cx="10032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ZoneTexte 16"/>
            <p:cNvSpPr txBox="1"/>
            <p:nvPr/>
          </p:nvSpPr>
          <p:spPr>
            <a:xfrm>
              <a:off x="1249629" y="231101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2330955" y="231101"/>
              <a:ext cx="6543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fr-FR" sz="10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srAB</a:t>
              </a:r>
              <a:endParaRPr lang="fr-FR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" name="ZoneTexte 19"/>
          <p:cNvSpPr txBox="1"/>
          <p:nvPr/>
        </p:nvSpPr>
        <p:spPr>
          <a:xfrm>
            <a:off x="3429000" y="1065529"/>
            <a:ext cx="3414717" cy="27084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1 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Heatma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display of </a:t>
            </a:r>
            <a:endParaRPr lang="en-US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ierarchical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lustering of the oxidized protein abundance </a:t>
            </a:r>
            <a:endParaRPr lang="en-US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smtClean="0">
                <a:latin typeface="Arial" panose="020B0604020202020204" pitchFamily="34" charset="0"/>
                <a:cs typeface="Arial" panose="020B0604020202020204" pitchFamily="34" charset="0"/>
              </a:rPr>
              <a:t>normalized by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z-score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 cellular samples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B. cereu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ach column represents one of the three biological </a:t>
            </a:r>
          </a:p>
          <a:p>
            <a:pPr algn="just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plicate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arvested at early exponential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E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,</a:t>
            </a:r>
          </a:p>
          <a:p>
            <a:pPr algn="just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at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xponential (LE) and stationary (S) growth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hases </a:t>
            </a:r>
          </a:p>
          <a:p>
            <a:pPr algn="just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or the wild-typ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train (WT) and the mutant strain </a:t>
            </a:r>
            <a:endParaRPr lang="en-US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msrA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endParaRPr lang="en-US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ach sample, proteins with high levels of oxidation are </a:t>
            </a:r>
            <a:endParaRPr lang="en-US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dicated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 red and proteins with low levels of oxidation </a:t>
            </a:r>
            <a:endParaRPr lang="en-US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r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dicated in green. A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dendrogra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is displayed at the </a:t>
            </a:r>
            <a:endParaRPr lang="en-US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eft of the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atmap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o visualize th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uclidean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rrelation </a:t>
            </a:r>
            <a:endParaRPr lang="en-US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etween each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ir of protein.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ows of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heatma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present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74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xidized cellular proteins </a:t>
            </a:r>
            <a:endParaRPr lang="en-US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abl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3). </a:t>
            </a:r>
            <a:endParaRPr lang="en-US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rotein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ith the highest oxidation levels ar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ainly </a:t>
            </a:r>
          </a:p>
          <a:p>
            <a:pPr algn="just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tress and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haperone-related proteins. 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Image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0674" y="11811000"/>
            <a:ext cx="4100082" cy="381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408422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</TotalTime>
  <Words>153</Words>
  <Application>Microsoft Office PowerPoint</Application>
  <PresentationFormat>Grand écran</PresentationFormat>
  <Paragraphs>2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uportc</dc:creator>
  <cp:lastModifiedBy>duportc</cp:lastModifiedBy>
  <cp:revision>9</cp:revision>
  <dcterms:created xsi:type="dcterms:W3CDTF">2017-07-24T11:17:22Z</dcterms:created>
  <dcterms:modified xsi:type="dcterms:W3CDTF">2018-01-23T17:00:14Z</dcterms:modified>
</cp:coreProperties>
</file>